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59" r:id="rId3"/>
    <p:sldId id="257" r:id="rId4"/>
    <p:sldId id="258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A409F3A-A790-4190-B737-9527D8D77D49}" v="8" dt="2025-06-18T01:58:09.52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71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eikh Abdullah" userId="8941c360-4296-48b1-84e9-5f565a04b052" providerId="ADAL" clId="{4A409F3A-A790-4190-B737-9527D8D77D49}"/>
    <pc:docChg chg="modSld">
      <pc:chgData name="Sheikh Abdullah" userId="8941c360-4296-48b1-84e9-5f565a04b052" providerId="ADAL" clId="{4A409F3A-A790-4190-B737-9527D8D77D49}" dt="2025-06-18T01:58:09.505" v="13"/>
      <pc:docMkLst>
        <pc:docMk/>
      </pc:docMkLst>
      <pc:sldChg chg="modSp mod">
        <pc:chgData name="Sheikh Abdullah" userId="8941c360-4296-48b1-84e9-5f565a04b052" providerId="ADAL" clId="{4A409F3A-A790-4190-B737-9527D8D77D49}" dt="2025-06-16T09:37:45.430" v="1" actId="20577"/>
        <pc:sldMkLst>
          <pc:docMk/>
          <pc:sldMk cId="227294033" sldId="257"/>
        </pc:sldMkLst>
        <pc:spChg chg="mod">
          <ac:chgData name="Sheikh Abdullah" userId="8941c360-4296-48b1-84e9-5f565a04b052" providerId="ADAL" clId="{4A409F3A-A790-4190-B737-9527D8D77D49}" dt="2025-06-16T09:37:45.430" v="1" actId="20577"/>
          <ac:spMkLst>
            <pc:docMk/>
            <pc:sldMk cId="227294033" sldId="257"/>
            <ac:spMk id="34" creationId="{6217134F-8CEA-A3A0-331B-6F0472FE632A}"/>
          </ac:spMkLst>
        </pc:spChg>
      </pc:sldChg>
      <pc:sldChg chg="addSp modSp mod">
        <pc:chgData name="Sheikh Abdullah" userId="8941c360-4296-48b1-84e9-5f565a04b052" providerId="ADAL" clId="{4A409F3A-A790-4190-B737-9527D8D77D49}" dt="2025-06-16T09:38:06.654" v="7" actId="20577"/>
        <pc:sldMkLst>
          <pc:docMk/>
          <pc:sldMk cId="321653095" sldId="258"/>
        </pc:sldMkLst>
        <pc:spChg chg="add mod">
          <ac:chgData name="Sheikh Abdullah" userId="8941c360-4296-48b1-84e9-5f565a04b052" providerId="ADAL" clId="{4A409F3A-A790-4190-B737-9527D8D77D49}" dt="2025-06-16T09:38:06.654" v="7" actId="20577"/>
          <ac:spMkLst>
            <pc:docMk/>
            <pc:sldMk cId="321653095" sldId="258"/>
            <ac:spMk id="56" creationId="{B08D22E9-0547-3438-C949-9E55EA05FB12}"/>
          </ac:spMkLst>
        </pc:spChg>
      </pc:sldChg>
      <pc:sldChg chg="modSp">
        <pc:chgData name="Sheikh Abdullah" userId="8941c360-4296-48b1-84e9-5f565a04b052" providerId="ADAL" clId="{4A409F3A-A790-4190-B737-9527D8D77D49}" dt="2025-06-18T01:58:09.505" v="13"/>
        <pc:sldMkLst>
          <pc:docMk/>
          <pc:sldMk cId="797507719" sldId="259"/>
        </pc:sldMkLst>
        <pc:picChg chg="mod">
          <ac:chgData name="Sheikh Abdullah" userId="8941c360-4296-48b1-84e9-5f565a04b052" providerId="ADAL" clId="{4A409F3A-A790-4190-B737-9527D8D77D49}" dt="2025-06-18T01:58:06.005" v="12"/>
          <ac:picMkLst>
            <pc:docMk/>
            <pc:sldMk cId="797507719" sldId="259"/>
            <ac:picMk id="4" creationId="{DBFF4E0A-7334-3134-0FC5-A481D56550A3}"/>
          </ac:picMkLst>
        </pc:picChg>
        <pc:picChg chg="mod">
          <ac:chgData name="Sheikh Abdullah" userId="8941c360-4296-48b1-84e9-5f565a04b052" providerId="ADAL" clId="{4A409F3A-A790-4190-B737-9527D8D77D49}" dt="2025-06-18T01:58:09.505" v="13"/>
          <ac:picMkLst>
            <pc:docMk/>
            <pc:sldMk cId="797507719" sldId="259"/>
            <ac:picMk id="5" creationId="{E00A39A5-5B3C-D4FA-4F67-6ADD7477FBD4}"/>
          </ac:picMkLst>
        </pc:picChg>
        <pc:picChg chg="mod">
          <ac:chgData name="Sheikh Abdullah" userId="8941c360-4296-48b1-84e9-5f565a04b052" providerId="ADAL" clId="{4A409F3A-A790-4190-B737-9527D8D77D49}" dt="2025-06-18T01:57:58.052" v="10"/>
          <ac:picMkLst>
            <pc:docMk/>
            <pc:sldMk cId="797507719" sldId="259"/>
            <ac:picMk id="6" creationId="{FF80ADC1-B2C7-CCF2-E4C8-9ECB4559383D}"/>
          </ac:picMkLst>
        </pc:picChg>
        <pc:picChg chg="mod">
          <ac:chgData name="Sheikh Abdullah" userId="8941c360-4296-48b1-84e9-5f565a04b052" providerId="ADAL" clId="{4A409F3A-A790-4190-B737-9527D8D77D49}" dt="2025-06-18T01:57:53.860" v="9"/>
          <ac:picMkLst>
            <pc:docMk/>
            <pc:sldMk cId="797507719" sldId="259"/>
            <ac:picMk id="7" creationId="{D85C94AC-FC23-102D-1A9D-8F329ED3631E}"/>
          </ac:picMkLst>
        </pc:picChg>
        <pc:picChg chg="mod">
          <ac:chgData name="Sheikh Abdullah" userId="8941c360-4296-48b1-84e9-5f565a04b052" providerId="ADAL" clId="{4A409F3A-A790-4190-B737-9527D8D77D49}" dt="2025-06-18T01:57:42.923" v="8"/>
          <ac:picMkLst>
            <pc:docMk/>
            <pc:sldMk cId="797507719" sldId="259"/>
            <ac:picMk id="8" creationId="{059B715D-1FB6-375F-5E37-6FC1E3230FF2}"/>
          </ac:picMkLst>
        </pc:picChg>
        <pc:picChg chg="mod">
          <ac:chgData name="Sheikh Abdullah" userId="8941c360-4296-48b1-84e9-5f565a04b052" providerId="ADAL" clId="{4A409F3A-A790-4190-B737-9527D8D77D49}" dt="2025-06-18T01:58:02.771" v="11"/>
          <ac:picMkLst>
            <pc:docMk/>
            <pc:sldMk cId="797507719" sldId="259"/>
            <ac:picMk id="9" creationId="{07270DF2-F769-13A7-72B2-95F2ED440528}"/>
          </ac:picMkLst>
        </pc:picChg>
      </pc:sldChg>
      <pc:sldChg chg="addSp modSp mod">
        <pc:chgData name="Sheikh Abdullah" userId="8941c360-4296-48b1-84e9-5f565a04b052" providerId="ADAL" clId="{4A409F3A-A790-4190-B737-9527D8D77D49}" dt="2025-06-16T09:38:00.154" v="5" actId="20577"/>
        <pc:sldMkLst>
          <pc:docMk/>
          <pc:sldMk cId="44206609" sldId="260"/>
        </pc:sldMkLst>
        <pc:spChg chg="add mod">
          <ac:chgData name="Sheikh Abdullah" userId="8941c360-4296-48b1-84e9-5f565a04b052" providerId="ADAL" clId="{4A409F3A-A790-4190-B737-9527D8D77D49}" dt="2025-06-16T09:38:00.154" v="5" actId="20577"/>
          <ac:spMkLst>
            <pc:docMk/>
            <pc:sldMk cId="44206609" sldId="260"/>
            <ac:spMk id="27" creationId="{AD876C96-5933-AE70-C723-1D59D92C602B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High%20fat%20diet%20kidney%20study\Western%20Blot\TGF%20beta%20receptor2\20230914%20rbr2%20wb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High%20fat%20diet%20kidney%20study\Western%20Blot\PDGFR-&#946;\PDGF-R%20be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3E5-4E38-ABB6-54E921970969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3E5-4E38-ABB6-54E921970969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3E5-4E38-ABB6-54E921970969}"/>
              </c:ext>
            </c:extLst>
          </c:dPt>
          <c:dPt>
            <c:idx val="5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E3E5-4E38-ABB6-54E921970969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R$13:$R$18</c:f>
                <c:numCache>
                  <c:formatCode>General</c:formatCode>
                  <c:ptCount val="6"/>
                  <c:pt idx="0">
                    <c:v>0.1337970524981287</c:v>
                  </c:pt>
                  <c:pt idx="1">
                    <c:v>0.26194415287499689</c:v>
                  </c:pt>
                  <c:pt idx="2">
                    <c:v>1.0189723992070491E-2</c:v>
                  </c:pt>
                  <c:pt idx="3">
                    <c:v>0.15160083695610482</c:v>
                  </c:pt>
                  <c:pt idx="4">
                    <c:v>9.8168063909821288E-2</c:v>
                  </c:pt>
                  <c:pt idx="5">
                    <c:v>0.2055175396263802</c:v>
                  </c:pt>
                </c:numCache>
              </c:numRef>
            </c:plus>
            <c:minus>
              <c:numRef>
                <c:f>Sheet1!$R$13:$R$18</c:f>
                <c:numCache>
                  <c:formatCode>General</c:formatCode>
                  <c:ptCount val="6"/>
                  <c:pt idx="0">
                    <c:v>0.1337970524981287</c:v>
                  </c:pt>
                  <c:pt idx="1">
                    <c:v>0.26194415287499689</c:v>
                  </c:pt>
                  <c:pt idx="2">
                    <c:v>1.0189723992070491E-2</c:v>
                  </c:pt>
                  <c:pt idx="3">
                    <c:v>0.15160083695610482</c:v>
                  </c:pt>
                  <c:pt idx="4">
                    <c:v>9.8168063909821288E-2</c:v>
                  </c:pt>
                  <c:pt idx="5">
                    <c:v>0.20551753962638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J$13:$J$18</c:f>
              <c:strCache>
                <c:ptCount val="6"/>
                <c:pt idx="0">
                  <c:v>WKY Control</c:v>
                </c:pt>
                <c:pt idx="1">
                  <c:v>WKY HFD</c:v>
                </c:pt>
                <c:pt idx="2">
                  <c:v>SHR Control</c:v>
                </c:pt>
                <c:pt idx="3">
                  <c:v>SHR HFD</c:v>
                </c:pt>
                <c:pt idx="4">
                  <c:v>SHRSP Control</c:v>
                </c:pt>
                <c:pt idx="5">
                  <c:v>SHRSP HFD</c:v>
                </c:pt>
              </c:strCache>
            </c:strRef>
          </c:cat>
          <c:val>
            <c:numRef>
              <c:f>Sheet1!$Q$13:$Q$18</c:f>
              <c:numCache>
                <c:formatCode>General</c:formatCode>
                <c:ptCount val="6"/>
                <c:pt idx="0">
                  <c:v>0.60207358511932807</c:v>
                </c:pt>
                <c:pt idx="1">
                  <c:v>0.9076357417085813</c:v>
                </c:pt>
                <c:pt idx="2">
                  <c:v>0.60827150767289162</c:v>
                </c:pt>
                <c:pt idx="3">
                  <c:v>0.86544915613596762</c:v>
                </c:pt>
                <c:pt idx="4">
                  <c:v>0.7927163313041875</c:v>
                </c:pt>
                <c:pt idx="5">
                  <c:v>0.974521754754087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E3E5-4E38-ABB6-54E9219709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77413487"/>
        <c:axId val="277413967"/>
      </c:barChart>
      <c:catAx>
        <c:axId val="27741348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77413967"/>
        <c:crosses val="autoZero"/>
        <c:auto val="1"/>
        <c:lblAlgn val="ctr"/>
        <c:lblOffset val="100"/>
        <c:noMultiLvlLbl val="0"/>
      </c:catAx>
      <c:valAx>
        <c:axId val="277413967"/>
        <c:scaling>
          <c:orientation val="minMax"/>
          <c:max val="1.6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77413487"/>
        <c:crosses val="autoZero"/>
        <c:crossBetween val="between"/>
        <c:majorUnit val="0.4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5A1-4FC3-B3CF-424E0D08DBEC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5A1-4FC3-B3CF-424E0D08DBEC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5A1-4FC3-B3CF-424E0D08DBEC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5A1-4FC3-B3CF-424E0D08DBEC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N$4:$N$9</c:f>
                <c:numCache>
                  <c:formatCode>General</c:formatCode>
                  <c:ptCount val="6"/>
                  <c:pt idx="0">
                    <c:v>8.8199704511965751E-2</c:v>
                  </c:pt>
                  <c:pt idx="1">
                    <c:v>0.34342278085101596</c:v>
                  </c:pt>
                  <c:pt idx="2">
                    <c:v>0.42473252088411617</c:v>
                  </c:pt>
                  <c:pt idx="3">
                    <c:v>0.26228610733532881</c:v>
                  </c:pt>
                  <c:pt idx="4">
                    <c:v>0.2780840942954092</c:v>
                  </c:pt>
                  <c:pt idx="5">
                    <c:v>0.37157224375947734</c:v>
                  </c:pt>
                </c:numCache>
              </c:numRef>
            </c:plus>
            <c:minus>
              <c:numRef>
                <c:f>Sheet1!$N$4:$N$9</c:f>
                <c:numCache>
                  <c:formatCode>General</c:formatCode>
                  <c:ptCount val="6"/>
                  <c:pt idx="0">
                    <c:v>8.8199704511965751E-2</c:v>
                  </c:pt>
                  <c:pt idx="1">
                    <c:v>0.34342278085101596</c:v>
                  </c:pt>
                  <c:pt idx="2">
                    <c:v>0.42473252088411617</c:v>
                  </c:pt>
                  <c:pt idx="3">
                    <c:v>0.26228610733532881</c:v>
                  </c:pt>
                  <c:pt idx="4">
                    <c:v>0.2780840942954092</c:v>
                  </c:pt>
                  <c:pt idx="5">
                    <c:v>0.371572243759477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I$4:$I$9</c:f>
              <c:strCache>
                <c:ptCount val="6"/>
                <c:pt idx="0">
                  <c:v>WKY Control</c:v>
                </c:pt>
                <c:pt idx="1">
                  <c:v>WKY HFD</c:v>
                </c:pt>
                <c:pt idx="2">
                  <c:v>SHR Control</c:v>
                </c:pt>
                <c:pt idx="3">
                  <c:v>SHR HFD</c:v>
                </c:pt>
                <c:pt idx="4">
                  <c:v>SHR-SP Control</c:v>
                </c:pt>
                <c:pt idx="5">
                  <c:v>SHR-SP HFD</c:v>
                </c:pt>
              </c:strCache>
            </c:strRef>
          </c:cat>
          <c:val>
            <c:numRef>
              <c:f>Sheet1!$M$4:$M$9</c:f>
              <c:numCache>
                <c:formatCode>General</c:formatCode>
                <c:ptCount val="6"/>
                <c:pt idx="0">
                  <c:v>0.53318861135346285</c:v>
                </c:pt>
                <c:pt idx="1">
                  <c:v>0.9711226007246766</c:v>
                </c:pt>
                <c:pt idx="2">
                  <c:v>0.57512417968776719</c:v>
                </c:pt>
                <c:pt idx="3">
                  <c:v>0.54155523956390761</c:v>
                </c:pt>
                <c:pt idx="4">
                  <c:v>0.6643933985270648</c:v>
                </c:pt>
                <c:pt idx="5">
                  <c:v>0.965993709311471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5A1-4FC3-B3CF-424E0D08DB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64041391"/>
        <c:axId val="1664038479"/>
      </c:barChart>
      <c:catAx>
        <c:axId val="16640413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64038479"/>
        <c:crosses val="autoZero"/>
        <c:auto val="1"/>
        <c:lblAlgn val="ctr"/>
        <c:lblOffset val="100"/>
        <c:noMultiLvlLbl val="0"/>
      </c:catAx>
      <c:valAx>
        <c:axId val="166403847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64041391"/>
        <c:crosses val="autoZero"/>
        <c:crossBetween val="between"/>
        <c:majorUnit val="0.4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CE8AA5-47F1-4A9B-BBF9-529CBC767841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263682-E828-449E-8CD5-BD7C96590F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3574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E at high magnifica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263682-E828-449E-8CD5-BD7C96590FD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8116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MC </a:t>
            </a:r>
            <a:r>
              <a:rPr lang="el-GR" dirty="0"/>
              <a:t>α</a:t>
            </a:r>
            <a:r>
              <a:rPr lang="en-US" dirty="0"/>
              <a:t>-actin, Bar= 100 µm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263682-E828-449E-8CD5-BD7C96590FD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22573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(A) Vimentin, (B) E-cadherin,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263682-E828-449E-8CD5-BD7C96590FD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9988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835C12-DC55-2217-CB69-2E1C4FB4D1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594478A-9A81-35F2-07B6-C7CA539751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804F8F-880A-9E6D-71FE-44F6FE2540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8A950-3F91-4FE2-A829-AC11A3F27D4E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4B00F8-E87C-F6C1-DC37-DBEC9EB74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395E8D-6D8B-40AE-F819-07B44D6081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94AB0-D1E2-4BB7-962C-9C85811C2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962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D0B486-AF9C-0065-6FE1-D824660B16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C84B834-743F-738C-9A43-DC6D9F1DA4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B51F3B-B058-ED75-78F7-D2ABE7BA14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8A950-3F91-4FE2-A829-AC11A3F27D4E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2731F4-0B25-8EEF-65C1-D95E46642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42A1E0-BE1A-D58B-A231-D24C67E3F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94AB0-D1E2-4BB7-962C-9C85811C2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7554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2CF6E2F-0548-AC97-464B-479FBCE1D3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5282CA-B5EB-7B60-1ADB-01ABFB9417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FB3586-9291-0143-200D-E72DC3C4DC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8A950-3F91-4FE2-A829-AC11A3F27D4E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FFC276-FB69-C284-051E-ECA0457BB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14D985-0099-6AB9-5292-597BC8C91A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94AB0-D1E2-4BB7-962C-9C85811C2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998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4B0CB5-FF7B-BF9D-D82F-C983B5DB47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40856F-A73A-8E6A-488E-7FFCB568AE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FC3342-7B78-289F-2E14-905401BD77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8A950-3F91-4FE2-A829-AC11A3F27D4E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38E4AF-8920-DB5C-37A2-DBE37EA721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3E0020-BB22-333A-8B89-A218156FF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94AB0-D1E2-4BB7-962C-9C85811C2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436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32D8FE-4C19-0613-CBC6-A932B3AAF5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1FC712-9258-C90D-B41B-2F4FFF10E2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A5F74C-2223-3EC5-BD05-88AC325A6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8A950-3F91-4FE2-A829-AC11A3F27D4E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AE9FF8-91ED-3D78-F241-5B5CB1A755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BB90C4-68F3-60D8-D88E-D23297AB64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94AB0-D1E2-4BB7-962C-9C85811C2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725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F98D8E-7188-F256-27E0-A4DD056E9A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5BB21-2C3B-F93B-DD16-82354FE31F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C7D505D-FC0D-8E1F-355D-35052F2039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8E2A01-2AF0-5D7E-464D-AA2AA70262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8A950-3F91-4FE2-A829-AC11A3F27D4E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9E9DCB-9CCD-9E18-8042-FED7A851B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A90141-0028-BF5C-A0BB-CFB6CD2140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94AB0-D1E2-4BB7-962C-9C85811C2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955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941DAF-BAB9-9CD5-304F-AA4E6D84E1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87DE8A-E77B-1917-4D68-C142A6A0EE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EA162C-7C0B-7CDA-EC2B-74FA82E939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65CBF88-23DD-BC60-0DA9-7D084234C2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D915F29-34B8-E993-5474-4534433ADFA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56E1CA4-03A7-274E-5A4F-C0498E2CFF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8A950-3F91-4FE2-A829-AC11A3F27D4E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04EE23A-99FF-D861-5B43-59347B4524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51FE91F-9ADF-2D74-BD8F-9E001C12B6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94AB0-D1E2-4BB7-962C-9C85811C2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4396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FCF492-8B66-D3A0-09C7-2B9514E96C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D3A1E0C-156B-3BA5-A679-A950974B2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8A950-3F91-4FE2-A829-AC11A3F27D4E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C723021-9604-2E92-A6BB-D22D0DDF2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B000491-9294-906E-D8DA-B424724BD0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94AB0-D1E2-4BB7-962C-9C85811C2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23135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52785B7-FE6A-7EDE-60ED-1E90248338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8A950-3F91-4FE2-A829-AC11A3F27D4E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6323E3-DD2D-A4BC-38F9-341E1FAA0F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F01300A-7632-EA58-785C-325C2B101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94AB0-D1E2-4BB7-962C-9C85811C2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2746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1D856C-9B16-AE43-49BA-CFFABA74AB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CF129C-C44A-F145-291A-4F69001926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845D9C-D202-95B8-8E4E-F06FB555F9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54BBA4-B51E-3EDF-03B0-370F4684A2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8A950-3F91-4FE2-A829-AC11A3F27D4E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02E0B6-AEE5-7BD2-9AAF-17BD088614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974ADD-228F-492E-73F6-50BEAD6A3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94AB0-D1E2-4BB7-962C-9C85811C2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3941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71F373-C8B4-4A85-275E-9D92ED9D88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FCB103A-6B81-C198-AD28-EA552D2964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A98FA7-47B8-1C7D-C821-42B331F3B2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024AC3-EB70-4CBD-0930-6C4E3B8A35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8A950-3F91-4FE2-A829-AC11A3F27D4E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BE0D2B-2DA7-50A7-EEA1-73F210954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EB39BA-E02F-25E7-F33D-4800041DA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94AB0-D1E2-4BB7-962C-9C85811C2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136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1ABC56E-C2A3-6F86-E497-E65F0B1ECA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FBB2F9-644F-B725-532B-9AE39D7120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C4C0F7-8308-6FCE-D9B8-0D1C6EC096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358A950-3F91-4FE2-A829-AC11A3F27D4E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E78B9E-BBA0-3C32-95D1-A83EACAA25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1E2230-2ACC-B990-B406-49D0387906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DF94AB0-D1E2-4BB7-962C-9C85811C2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3613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3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5.png"/><Relationship Id="rId14" Type="http://schemas.microsoft.com/office/2007/relationships/hdphoto" Target="../media/hdphoto6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8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Relationship Id="rId14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7.wdp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.xml"/><Relationship Id="rId4" Type="http://schemas.openxmlformats.org/officeDocument/2006/relationships/image" Target="../media/image21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2.xml"/><Relationship Id="rId4" Type="http://schemas.microsoft.com/office/2007/relationships/hdphoto" Target="../media/hdphoto8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1ED3A05-85D4-E581-535C-D1D5510C7F10}"/>
              </a:ext>
            </a:extLst>
          </p:cNvPr>
          <p:cNvSpPr txBox="1"/>
          <p:nvPr/>
        </p:nvSpPr>
        <p:spPr>
          <a:xfrm>
            <a:off x="4912068" y="251173"/>
            <a:ext cx="2521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6956DDF2-E5DE-E2E3-4C8A-CEAE5128D154}"/>
              </a:ext>
            </a:extLst>
          </p:cNvPr>
          <p:cNvGrpSpPr/>
          <p:nvPr/>
        </p:nvGrpSpPr>
        <p:grpSpPr>
          <a:xfrm>
            <a:off x="2320388" y="974941"/>
            <a:ext cx="7571888" cy="4082728"/>
            <a:chOff x="2320388" y="974941"/>
            <a:chExt cx="7571888" cy="408272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C774947-4995-FAA6-3BCD-9C3EA21800F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20388" y="1381462"/>
              <a:ext cx="7571888" cy="3676207"/>
            </a:xfrm>
            <a:prstGeom prst="rect">
              <a:avLst/>
            </a:prstGeom>
          </p:spPr>
        </p:pic>
        <p:sp>
          <p:nvSpPr>
            <p:cNvPr id="6" name="テキスト ボックス 12">
              <a:extLst>
                <a:ext uri="{FF2B5EF4-FFF2-40B4-BE49-F238E27FC236}">
                  <a16:creationId xmlns:a16="http://schemas.microsoft.com/office/drawing/2014/main" id="{BE85571D-B0F6-682A-BC49-9EDAC5AE1E06}"/>
                </a:ext>
              </a:extLst>
            </p:cNvPr>
            <p:cNvSpPr txBox="1"/>
            <p:nvPr/>
          </p:nvSpPr>
          <p:spPr>
            <a:xfrm>
              <a:off x="3734184" y="976753"/>
              <a:ext cx="723275" cy="3693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8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KY</a:t>
              </a:r>
              <a:endParaRPr kumimoji="1" lang="ja-JP" altLang="en-US" sz="18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13">
              <a:extLst>
                <a:ext uri="{FF2B5EF4-FFF2-40B4-BE49-F238E27FC236}">
                  <a16:creationId xmlns:a16="http://schemas.microsoft.com/office/drawing/2014/main" id="{6479BA1F-4831-CD18-A389-0CD6C72AA94E}"/>
                </a:ext>
              </a:extLst>
            </p:cNvPr>
            <p:cNvSpPr txBox="1"/>
            <p:nvPr/>
          </p:nvSpPr>
          <p:spPr>
            <a:xfrm>
              <a:off x="6128899" y="974941"/>
              <a:ext cx="671979" cy="3693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8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HR</a:t>
              </a:r>
              <a:endParaRPr kumimoji="1" lang="ja-JP" altLang="en-US" sz="18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14">
              <a:extLst>
                <a:ext uri="{FF2B5EF4-FFF2-40B4-BE49-F238E27FC236}">
                  <a16:creationId xmlns:a16="http://schemas.microsoft.com/office/drawing/2014/main" id="{8133FA84-B58C-D883-41EC-348C5A4EDEA0}"/>
                </a:ext>
              </a:extLst>
            </p:cNvPr>
            <p:cNvSpPr txBox="1"/>
            <p:nvPr/>
          </p:nvSpPr>
          <p:spPr>
            <a:xfrm>
              <a:off x="8204253" y="981153"/>
              <a:ext cx="1056700" cy="3693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8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HR-SP</a:t>
              </a:r>
              <a:endParaRPr kumimoji="1" lang="ja-JP" altLang="en-US" sz="18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874179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BFF4E0A-7334-3134-0FC5-A481D56550A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689888" y="1471146"/>
            <a:ext cx="2918593" cy="233563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00A39A5-5B3C-D4FA-4F67-6ADD7477FBD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691043" y="3865666"/>
            <a:ext cx="2922378" cy="233563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F80ADC1-B2C7-CCF2-E4C8-9ECB4559383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701886" y="3865666"/>
            <a:ext cx="2918593" cy="233563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85C94AC-FC23-102D-1A9D-8F329ED3631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13887" y="3861187"/>
            <a:ext cx="2918593" cy="233563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59B715D-1FB6-375F-5E37-6FC1E3230FF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19073" y="1471146"/>
            <a:ext cx="2918593" cy="233563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7270DF2-F769-13A7-72B2-95F2ED440528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695177" y="1475626"/>
            <a:ext cx="2922378" cy="233563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D1DA26C7-1454-91F8-9497-B318D733DEB5}"/>
              </a:ext>
            </a:extLst>
          </p:cNvPr>
          <p:cNvSpPr txBox="1"/>
          <p:nvPr/>
        </p:nvSpPr>
        <p:spPr>
          <a:xfrm>
            <a:off x="4901650" y="437156"/>
            <a:ext cx="2521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</a:t>
            </a:r>
          </a:p>
        </p:txBody>
      </p:sp>
      <p:sp>
        <p:nvSpPr>
          <p:cNvPr id="11" name="テキスト ボックス 12">
            <a:extLst>
              <a:ext uri="{FF2B5EF4-FFF2-40B4-BE49-F238E27FC236}">
                <a16:creationId xmlns:a16="http://schemas.microsoft.com/office/drawing/2014/main" id="{FF21FB8E-E374-A520-556B-445E163FECCE}"/>
              </a:ext>
            </a:extLst>
          </p:cNvPr>
          <p:cNvSpPr txBox="1"/>
          <p:nvPr/>
        </p:nvSpPr>
        <p:spPr>
          <a:xfrm>
            <a:off x="2902354" y="1072517"/>
            <a:ext cx="723275" cy="3693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8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KY</a:t>
            </a:r>
            <a:endParaRPr kumimoji="1" lang="ja-JP" altLang="en-US" sz="18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3">
            <a:extLst>
              <a:ext uri="{FF2B5EF4-FFF2-40B4-BE49-F238E27FC236}">
                <a16:creationId xmlns:a16="http://schemas.microsoft.com/office/drawing/2014/main" id="{F4161D0C-8BBF-8131-C5D8-FDC8FB5B9507}"/>
              </a:ext>
            </a:extLst>
          </p:cNvPr>
          <p:cNvSpPr txBox="1"/>
          <p:nvPr/>
        </p:nvSpPr>
        <p:spPr>
          <a:xfrm>
            <a:off x="5766112" y="1070705"/>
            <a:ext cx="671979" cy="3693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8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R</a:t>
            </a:r>
            <a:endParaRPr kumimoji="1" lang="ja-JP" altLang="en-US" sz="18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4">
            <a:extLst>
              <a:ext uri="{FF2B5EF4-FFF2-40B4-BE49-F238E27FC236}">
                <a16:creationId xmlns:a16="http://schemas.microsoft.com/office/drawing/2014/main" id="{E11B7A48-AE5E-6DD2-9096-48FABF305AC2}"/>
              </a:ext>
            </a:extLst>
          </p:cNvPr>
          <p:cNvSpPr txBox="1"/>
          <p:nvPr/>
        </p:nvSpPr>
        <p:spPr>
          <a:xfrm>
            <a:off x="8788180" y="1052853"/>
            <a:ext cx="979755" cy="3693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800" b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RSP</a:t>
            </a:r>
            <a:endParaRPr kumimoji="1" lang="ja-JP" altLang="en-US" sz="1800" b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5">
            <a:extLst>
              <a:ext uri="{FF2B5EF4-FFF2-40B4-BE49-F238E27FC236}">
                <a16:creationId xmlns:a16="http://schemas.microsoft.com/office/drawing/2014/main" id="{612D3C85-01F9-A8E5-F568-03CDA117BCCC}"/>
              </a:ext>
            </a:extLst>
          </p:cNvPr>
          <p:cNvSpPr txBox="1"/>
          <p:nvPr/>
        </p:nvSpPr>
        <p:spPr>
          <a:xfrm rot="16200000">
            <a:off x="988372" y="2434664"/>
            <a:ext cx="1005403" cy="3693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8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18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6">
            <a:extLst>
              <a:ext uri="{FF2B5EF4-FFF2-40B4-BE49-F238E27FC236}">
                <a16:creationId xmlns:a16="http://schemas.microsoft.com/office/drawing/2014/main" id="{7DF4F9D8-252E-2948-27BF-5FE0BFAAB589}"/>
              </a:ext>
            </a:extLst>
          </p:cNvPr>
          <p:cNvSpPr txBox="1"/>
          <p:nvPr/>
        </p:nvSpPr>
        <p:spPr>
          <a:xfrm rot="16200000">
            <a:off x="1148434" y="4711369"/>
            <a:ext cx="659155" cy="3693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8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FD</a:t>
            </a:r>
            <a:endParaRPr kumimoji="1" lang="ja-JP" altLang="en-US" sz="18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3A8556A2-30D1-1EFD-F27A-C03C9B5506AF}"/>
              </a:ext>
            </a:extLst>
          </p:cNvPr>
          <p:cNvCxnSpPr>
            <a:cxnSpLocks/>
          </p:cNvCxnSpPr>
          <p:nvPr/>
        </p:nvCxnSpPr>
        <p:spPr>
          <a:xfrm>
            <a:off x="9748299" y="5971426"/>
            <a:ext cx="492981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975077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Group 34">
            <a:extLst>
              <a:ext uri="{FF2B5EF4-FFF2-40B4-BE49-F238E27FC236}">
                <a16:creationId xmlns:a16="http://schemas.microsoft.com/office/drawing/2014/main" id="{54A95CB9-7150-EDCF-EAFE-544F177D161C}"/>
              </a:ext>
            </a:extLst>
          </p:cNvPr>
          <p:cNvGrpSpPr/>
          <p:nvPr/>
        </p:nvGrpSpPr>
        <p:grpSpPr>
          <a:xfrm>
            <a:off x="-41612" y="259729"/>
            <a:ext cx="12121898" cy="4176221"/>
            <a:chOff x="-41612" y="-518197"/>
            <a:chExt cx="12121898" cy="4176221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1E63A34-83A2-D629-ED65-01622EA9858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0479" y="772793"/>
              <a:ext cx="1908213" cy="1414395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C64922C-A80D-D822-57BC-BC3857606CF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41461" y="780740"/>
              <a:ext cx="1822862" cy="1414395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A1216592-466C-47B6-04EF-92702AB80AF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091199" y="783786"/>
              <a:ext cx="1908213" cy="1408298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FF0FDCE-364D-7C33-CFCB-CDF60EE811A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092174" y="2229144"/>
              <a:ext cx="1908213" cy="1414395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1BF7EEE-17BB-57F0-6ECF-37EA7DF03D2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244516" y="2227874"/>
              <a:ext cx="1816765" cy="1414395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695427B7-84FE-59CF-7141-02D5136FF03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90472" y="2227874"/>
              <a:ext cx="1908213" cy="1414395"/>
            </a:xfrm>
            <a:prstGeom prst="rect">
              <a:avLst/>
            </a:prstGeom>
          </p:spPr>
        </p:pic>
        <p:sp>
          <p:nvSpPr>
            <p:cNvPr id="8" name="テキスト ボックス 2">
              <a:extLst>
                <a:ext uri="{FF2B5EF4-FFF2-40B4-BE49-F238E27FC236}">
                  <a16:creationId xmlns:a16="http://schemas.microsoft.com/office/drawing/2014/main" id="{B909FAE3-162C-E422-3D61-054F4700A74D}"/>
                </a:ext>
              </a:extLst>
            </p:cNvPr>
            <p:cNvSpPr txBox="1"/>
            <p:nvPr/>
          </p:nvSpPr>
          <p:spPr>
            <a:xfrm>
              <a:off x="944817" y="445371"/>
              <a:ext cx="6046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WKY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3">
              <a:extLst>
                <a:ext uri="{FF2B5EF4-FFF2-40B4-BE49-F238E27FC236}">
                  <a16:creationId xmlns:a16="http://schemas.microsoft.com/office/drawing/2014/main" id="{48684BD0-1B23-8C38-B848-0A9177896BF8}"/>
                </a:ext>
              </a:extLst>
            </p:cNvPr>
            <p:cNvSpPr txBox="1"/>
            <p:nvPr/>
          </p:nvSpPr>
          <p:spPr>
            <a:xfrm>
              <a:off x="2967130" y="438204"/>
              <a:ext cx="5645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HR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4">
              <a:extLst>
                <a:ext uri="{FF2B5EF4-FFF2-40B4-BE49-F238E27FC236}">
                  <a16:creationId xmlns:a16="http://schemas.microsoft.com/office/drawing/2014/main" id="{FD26748A-A30F-2E8E-660A-791DB37A08F6}"/>
                </a:ext>
              </a:extLst>
            </p:cNvPr>
            <p:cNvSpPr txBox="1"/>
            <p:nvPr/>
          </p:nvSpPr>
          <p:spPr>
            <a:xfrm>
              <a:off x="4773026" y="442054"/>
              <a:ext cx="8643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HR-SP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7">
              <a:extLst>
                <a:ext uri="{FF2B5EF4-FFF2-40B4-BE49-F238E27FC236}">
                  <a16:creationId xmlns:a16="http://schemas.microsoft.com/office/drawing/2014/main" id="{046D28E7-09AD-A8E7-E43C-22CA49A2188B}"/>
                </a:ext>
              </a:extLst>
            </p:cNvPr>
            <p:cNvSpPr txBox="1"/>
            <p:nvPr/>
          </p:nvSpPr>
          <p:spPr>
            <a:xfrm rot="16200000">
              <a:off x="-287203" y="1287348"/>
              <a:ext cx="82105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9">
              <a:extLst>
                <a:ext uri="{FF2B5EF4-FFF2-40B4-BE49-F238E27FC236}">
                  <a16:creationId xmlns:a16="http://schemas.microsoft.com/office/drawing/2014/main" id="{31FAC991-35AF-B602-7CDB-0DEA2F80B4C6}"/>
                </a:ext>
              </a:extLst>
            </p:cNvPr>
            <p:cNvSpPr txBox="1"/>
            <p:nvPr/>
          </p:nvSpPr>
          <p:spPr>
            <a:xfrm rot="16200000">
              <a:off x="-115934" y="2751586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FD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4EAFBBE5-AF86-D93C-D098-1A17AFAEFA0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720647" y="2249726"/>
              <a:ext cx="1755800" cy="1408298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6C18CEF8-0B8B-D496-4319-B55BD2738D5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8524362" y="2240325"/>
              <a:ext cx="1755800" cy="1408298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9CC724EF-2C99-7F15-0ECB-BE1D6718B21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0324486" y="2240324"/>
              <a:ext cx="1755800" cy="1408298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316B4E68-2A49-F15E-26B0-D6DEF13EDC0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0318389" y="805332"/>
              <a:ext cx="1761897" cy="1408298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6D106E89-6830-D832-B0AC-766F7966AA99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8520397" y="795707"/>
              <a:ext cx="1759766" cy="1408298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AFC04DB0-6D10-0BB1-F0BF-4A5CCD848F05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6720647" y="803099"/>
              <a:ext cx="1755800" cy="1408298"/>
            </a:xfrm>
            <a:prstGeom prst="rect">
              <a:avLst/>
            </a:prstGeom>
          </p:spPr>
        </p:pic>
        <p:sp>
          <p:nvSpPr>
            <p:cNvPr id="19" name="テキスト ボックス 2">
              <a:extLst>
                <a:ext uri="{FF2B5EF4-FFF2-40B4-BE49-F238E27FC236}">
                  <a16:creationId xmlns:a16="http://schemas.microsoft.com/office/drawing/2014/main" id="{11EE5564-2FBA-981F-B4CF-DE6719998C08}"/>
                </a:ext>
              </a:extLst>
            </p:cNvPr>
            <p:cNvSpPr txBox="1"/>
            <p:nvPr/>
          </p:nvSpPr>
          <p:spPr>
            <a:xfrm>
              <a:off x="7363168" y="495946"/>
              <a:ext cx="6046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WKY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3">
              <a:extLst>
                <a:ext uri="{FF2B5EF4-FFF2-40B4-BE49-F238E27FC236}">
                  <a16:creationId xmlns:a16="http://schemas.microsoft.com/office/drawing/2014/main" id="{6B172321-884D-596F-59D8-1394ED0A7C93}"/>
                </a:ext>
              </a:extLst>
            </p:cNvPr>
            <p:cNvSpPr txBox="1"/>
            <p:nvPr/>
          </p:nvSpPr>
          <p:spPr>
            <a:xfrm>
              <a:off x="9385481" y="488779"/>
              <a:ext cx="5645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HR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4">
              <a:extLst>
                <a:ext uri="{FF2B5EF4-FFF2-40B4-BE49-F238E27FC236}">
                  <a16:creationId xmlns:a16="http://schemas.microsoft.com/office/drawing/2014/main" id="{3841620A-6357-4F34-9951-612B020C9821}"/>
                </a:ext>
              </a:extLst>
            </p:cNvPr>
            <p:cNvSpPr txBox="1"/>
            <p:nvPr/>
          </p:nvSpPr>
          <p:spPr>
            <a:xfrm>
              <a:off x="11191377" y="492629"/>
              <a:ext cx="8643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HR-SP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17">
              <a:extLst>
                <a:ext uri="{FF2B5EF4-FFF2-40B4-BE49-F238E27FC236}">
                  <a16:creationId xmlns:a16="http://schemas.microsoft.com/office/drawing/2014/main" id="{DFED0AC2-4B11-B302-4563-16E4E131CBAA}"/>
                </a:ext>
              </a:extLst>
            </p:cNvPr>
            <p:cNvSpPr txBox="1"/>
            <p:nvPr/>
          </p:nvSpPr>
          <p:spPr>
            <a:xfrm rot="16200000">
              <a:off x="6131148" y="1337923"/>
              <a:ext cx="82105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19">
              <a:extLst>
                <a:ext uri="{FF2B5EF4-FFF2-40B4-BE49-F238E27FC236}">
                  <a16:creationId xmlns:a16="http://schemas.microsoft.com/office/drawing/2014/main" id="{74EBE53C-D96C-6EA6-D050-60ACF194F554}"/>
                </a:ext>
              </a:extLst>
            </p:cNvPr>
            <p:cNvSpPr txBox="1"/>
            <p:nvPr/>
          </p:nvSpPr>
          <p:spPr>
            <a:xfrm rot="16200000">
              <a:off x="6302417" y="2802161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FD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FA2C076-BFF0-55D6-D4DC-04E45D15CB18}"/>
                </a:ext>
              </a:extLst>
            </p:cNvPr>
            <p:cNvSpPr txBox="1"/>
            <p:nvPr/>
          </p:nvSpPr>
          <p:spPr>
            <a:xfrm>
              <a:off x="-41612" y="304806"/>
              <a:ext cx="4700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2AC2314-B9B4-DA6D-4A05-C6F9F9DCB240}"/>
                </a:ext>
              </a:extLst>
            </p:cNvPr>
            <p:cNvSpPr txBox="1"/>
            <p:nvPr/>
          </p:nvSpPr>
          <p:spPr>
            <a:xfrm>
              <a:off x="6314777" y="365978"/>
              <a:ext cx="4700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</a:p>
          </p:txBody>
        </p: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7706733D-D390-D42D-C719-FCD76D80FB2E}"/>
                </a:ext>
              </a:extLst>
            </p:cNvPr>
            <p:cNvCxnSpPr/>
            <p:nvPr/>
          </p:nvCxnSpPr>
          <p:spPr>
            <a:xfrm>
              <a:off x="5507902" y="3545653"/>
              <a:ext cx="42762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B314E22D-446F-AA94-B1E5-13EF8956E259}"/>
                </a:ext>
              </a:extLst>
            </p:cNvPr>
            <p:cNvCxnSpPr/>
            <p:nvPr/>
          </p:nvCxnSpPr>
          <p:spPr>
            <a:xfrm>
              <a:off x="7969334" y="3534032"/>
              <a:ext cx="311274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217134F-8CEA-A3A0-331B-6F0472FE632A}"/>
                </a:ext>
              </a:extLst>
            </p:cNvPr>
            <p:cNvSpPr txBox="1"/>
            <p:nvPr/>
          </p:nvSpPr>
          <p:spPr>
            <a:xfrm>
              <a:off x="4901650" y="-518197"/>
              <a:ext cx="25218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l Figure S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72940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>
            <a:extLst>
              <a:ext uri="{FF2B5EF4-FFF2-40B4-BE49-F238E27FC236}">
                <a16:creationId xmlns:a16="http://schemas.microsoft.com/office/drawing/2014/main" id="{B6A8946B-8ACC-C78E-5544-B4B36AD31F18}"/>
              </a:ext>
            </a:extLst>
          </p:cNvPr>
          <p:cNvGrpSpPr/>
          <p:nvPr/>
        </p:nvGrpSpPr>
        <p:grpSpPr>
          <a:xfrm>
            <a:off x="126144" y="892352"/>
            <a:ext cx="4903646" cy="2717778"/>
            <a:chOff x="530204" y="7578920"/>
            <a:chExt cx="4903646" cy="2717778"/>
          </a:xfrm>
        </p:grpSpPr>
        <p:sp>
          <p:nvSpPr>
            <p:cNvPr id="35" name="テキスト ボックス 24">
              <a:extLst>
                <a:ext uri="{FF2B5EF4-FFF2-40B4-BE49-F238E27FC236}">
                  <a16:creationId xmlns:a16="http://schemas.microsoft.com/office/drawing/2014/main" id="{A0D28D9D-4E47-C83C-763B-0D213D1F3602}"/>
                </a:ext>
              </a:extLst>
            </p:cNvPr>
            <p:cNvSpPr txBox="1"/>
            <p:nvPr/>
          </p:nvSpPr>
          <p:spPr>
            <a:xfrm>
              <a:off x="674403" y="9039328"/>
              <a:ext cx="7777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GFβR2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55">
              <a:extLst>
                <a:ext uri="{FF2B5EF4-FFF2-40B4-BE49-F238E27FC236}">
                  <a16:creationId xmlns:a16="http://schemas.microsoft.com/office/drawing/2014/main" id="{F0E40CC0-A481-5ED5-E8A5-D8DB1965B8AD}"/>
                </a:ext>
              </a:extLst>
            </p:cNvPr>
            <p:cNvSpPr txBox="1"/>
            <p:nvPr/>
          </p:nvSpPr>
          <p:spPr>
            <a:xfrm>
              <a:off x="635770" y="9776728"/>
              <a:ext cx="7152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l-GR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37" name="テキスト ボックス 1">
              <a:extLst>
                <a:ext uri="{FF2B5EF4-FFF2-40B4-BE49-F238E27FC236}">
                  <a16:creationId xmlns:a16="http://schemas.microsoft.com/office/drawing/2014/main" id="{1D55BCF7-137F-6EA8-56B5-EEE03506328C}"/>
                </a:ext>
              </a:extLst>
            </p:cNvPr>
            <p:cNvSpPr txBox="1"/>
            <p:nvPr/>
          </p:nvSpPr>
          <p:spPr>
            <a:xfrm>
              <a:off x="530204" y="7578920"/>
              <a:ext cx="5052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8" name="Picture 37" descr="A black line on a white background&#10;&#10;Description automatically generated">
              <a:extLst>
                <a:ext uri="{FF2B5EF4-FFF2-40B4-BE49-F238E27FC236}">
                  <a16:creationId xmlns:a16="http://schemas.microsoft.com/office/drawing/2014/main" id="{A2E97CE7-ADDF-2852-FAFA-E4CC38A2F55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518" t="57627" r="2725" b="35046"/>
            <a:stretch/>
          </p:blipFill>
          <p:spPr>
            <a:xfrm>
              <a:off x="1498407" y="9586406"/>
              <a:ext cx="3935443" cy="710292"/>
            </a:xfrm>
            <a:prstGeom prst="rect">
              <a:avLst/>
            </a:prstGeom>
          </p:spPr>
        </p:pic>
        <p:pic>
          <p:nvPicPr>
            <p:cNvPr id="39" name="Picture 38" descr="A close-up of a x-ray&#10;&#10;Description automatically generated">
              <a:extLst>
                <a:ext uri="{FF2B5EF4-FFF2-40B4-BE49-F238E27FC236}">
                  <a16:creationId xmlns:a16="http://schemas.microsoft.com/office/drawing/2014/main" id="{06E0B03A-3801-6F0C-A86E-C3E41F287A3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371" t="37018" r="23311" b="52920"/>
            <a:stretch/>
          </p:blipFill>
          <p:spPr>
            <a:xfrm>
              <a:off x="1498408" y="8806898"/>
              <a:ext cx="3935441" cy="710292"/>
            </a:xfrm>
            <a:prstGeom prst="rect">
              <a:avLst/>
            </a:prstGeom>
          </p:spPr>
        </p:pic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897D463B-03DF-F0C7-EB58-91C606ED10B4}"/>
                </a:ext>
              </a:extLst>
            </p:cNvPr>
            <p:cNvGrpSpPr/>
            <p:nvPr/>
          </p:nvGrpSpPr>
          <p:grpSpPr>
            <a:xfrm>
              <a:off x="1612235" y="8028507"/>
              <a:ext cx="3376764" cy="700804"/>
              <a:chOff x="8285750" y="3151706"/>
              <a:chExt cx="3376764" cy="700804"/>
            </a:xfrm>
          </p:grpSpPr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4F594C14-C832-A0EA-D273-692D99CAA1D7}"/>
                  </a:ext>
                </a:extLst>
              </p:cNvPr>
              <p:cNvSpPr txBox="1"/>
              <p:nvPr/>
            </p:nvSpPr>
            <p:spPr>
              <a:xfrm>
                <a:off x="8502316" y="3151706"/>
                <a:ext cx="60465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KY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8BE03E89-30AF-55C6-4BD7-2222BEF167D6}"/>
                  </a:ext>
                </a:extLst>
              </p:cNvPr>
              <p:cNvSpPr txBox="1"/>
              <p:nvPr/>
            </p:nvSpPr>
            <p:spPr>
              <a:xfrm>
                <a:off x="9665365" y="3159729"/>
                <a:ext cx="56457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R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82A2FFA5-17D7-2167-E945-B55D48E28027}"/>
                  </a:ext>
                </a:extLst>
              </p:cNvPr>
              <p:cNvSpPr txBox="1"/>
              <p:nvPr/>
            </p:nvSpPr>
            <p:spPr>
              <a:xfrm>
                <a:off x="10643939" y="3159729"/>
                <a:ext cx="86433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R-SP</a:t>
                </a:r>
              </a:p>
            </p:txBody>
          </p:sp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411F41A8-31AE-EEBF-69DA-C527F372BA5F}"/>
                  </a:ext>
                </a:extLst>
              </p:cNvPr>
              <p:cNvGrpSpPr/>
              <p:nvPr/>
            </p:nvGrpSpPr>
            <p:grpSpPr>
              <a:xfrm>
                <a:off x="8285750" y="3505818"/>
                <a:ext cx="1122850" cy="338670"/>
                <a:chOff x="8285750" y="3505818"/>
                <a:chExt cx="1122850" cy="338670"/>
              </a:xfrm>
            </p:grpSpPr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8EC6AAF7-7EF1-169C-7EB6-6C56EBAE58F3}"/>
                    </a:ext>
                  </a:extLst>
                </p:cNvPr>
                <p:cNvSpPr txBox="1"/>
                <p:nvPr/>
              </p:nvSpPr>
              <p:spPr>
                <a:xfrm>
                  <a:off x="8285750" y="3528689"/>
                  <a:ext cx="53251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</a:t>
                  </a:r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4687D192-5B06-10C2-7327-1F5259700FCB}"/>
                    </a:ext>
                  </a:extLst>
                </p:cNvPr>
                <p:cNvSpPr txBox="1"/>
                <p:nvPr/>
              </p:nvSpPr>
              <p:spPr>
                <a:xfrm>
                  <a:off x="8855243" y="3536711"/>
                  <a:ext cx="55335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FD</a:t>
                  </a:r>
                </a:p>
              </p:txBody>
            </p:sp>
            <p:cxnSp>
              <p:nvCxnSpPr>
                <p:cNvPr id="55" name="Straight Connector 54">
                  <a:extLst>
                    <a:ext uri="{FF2B5EF4-FFF2-40B4-BE49-F238E27FC236}">
                      <a16:creationId xmlns:a16="http://schemas.microsoft.com/office/drawing/2014/main" id="{A7B25662-8D0A-2EE6-165F-C5D88D895AD4}"/>
                    </a:ext>
                  </a:extLst>
                </p:cNvPr>
                <p:cNvCxnSpPr/>
                <p:nvPr/>
              </p:nvCxnSpPr>
              <p:spPr>
                <a:xfrm>
                  <a:off x="8385218" y="3505818"/>
                  <a:ext cx="870958" cy="0"/>
                </a:xfrm>
                <a:prstGeom prst="line">
                  <a:avLst/>
                </a:prstGeom>
                <a:ln w="28575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8F481923-567E-B514-F3C9-C18E3785821A}"/>
                  </a:ext>
                </a:extLst>
              </p:cNvPr>
              <p:cNvGrpSpPr/>
              <p:nvPr/>
            </p:nvGrpSpPr>
            <p:grpSpPr>
              <a:xfrm>
                <a:off x="9432761" y="3513840"/>
                <a:ext cx="1122850" cy="338670"/>
                <a:chOff x="8285750" y="3505818"/>
                <a:chExt cx="1122850" cy="338670"/>
              </a:xfrm>
            </p:grpSpPr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B443EC39-0816-A3E2-2BDC-D0F40A9F70A9}"/>
                    </a:ext>
                  </a:extLst>
                </p:cNvPr>
                <p:cNvSpPr txBox="1"/>
                <p:nvPr/>
              </p:nvSpPr>
              <p:spPr>
                <a:xfrm>
                  <a:off x="8285750" y="3528689"/>
                  <a:ext cx="53251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</a:t>
                  </a:r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E1DD1971-A2D5-38EA-77DD-F42654DAA213}"/>
                    </a:ext>
                  </a:extLst>
                </p:cNvPr>
                <p:cNvSpPr txBox="1"/>
                <p:nvPr/>
              </p:nvSpPr>
              <p:spPr>
                <a:xfrm>
                  <a:off x="8855243" y="3536711"/>
                  <a:ext cx="55335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FD</a:t>
                  </a:r>
                </a:p>
              </p:txBody>
            </p:sp>
            <p:cxnSp>
              <p:nvCxnSpPr>
                <p:cNvPr id="52" name="Straight Connector 51">
                  <a:extLst>
                    <a:ext uri="{FF2B5EF4-FFF2-40B4-BE49-F238E27FC236}">
                      <a16:creationId xmlns:a16="http://schemas.microsoft.com/office/drawing/2014/main" id="{FB2C836F-C336-D6CB-54BA-B9461D3CF8E9}"/>
                    </a:ext>
                  </a:extLst>
                </p:cNvPr>
                <p:cNvCxnSpPr/>
                <p:nvPr/>
              </p:nvCxnSpPr>
              <p:spPr>
                <a:xfrm>
                  <a:off x="8385218" y="3505818"/>
                  <a:ext cx="870958" cy="0"/>
                </a:xfrm>
                <a:prstGeom prst="line">
                  <a:avLst/>
                </a:prstGeom>
                <a:ln w="28575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6" name="Group 45">
                <a:extLst>
                  <a:ext uri="{FF2B5EF4-FFF2-40B4-BE49-F238E27FC236}">
                    <a16:creationId xmlns:a16="http://schemas.microsoft.com/office/drawing/2014/main" id="{F40A5CBF-8F12-7E81-088E-B03C56380F7C}"/>
                  </a:ext>
                </a:extLst>
              </p:cNvPr>
              <p:cNvGrpSpPr/>
              <p:nvPr/>
            </p:nvGrpSpPr>
            <p:grpSpPr>
              <a:xfrm>
                <a:off x="10539664" y="3513840"/>
                <a:ext cx="1122850" cy="338670"/>
                <a:chOff x="8285750" y="3505818"/>
                <a:chExt cx="1122850" cy="338670"/>
              </a:xfrm>
            </p:grpSpPr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DFA88571-47B2-AA95-8E0A-16956E85AB61}"/>
                    </a:ext>
                  </a:extLst>
                </p:cNvPr>
                <p:cNvSpPr txBox="1"/>
                <p:nvPr/>
              </p:nvSpPr>
              <p:spPr>
                <a:xfrm>
                  <a:off x="8285750" y="3528689"/>
                  <a:ext cx="53251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</a:t>
                  </a: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FD7700D9-E140-D952-482A-CBC6A0B55795}"/>
                    </a:ext>
                  </a:extLst>
                </p:cNvPr>
                <p:cNvSpPr txBox="1"/>
                <p:nvPr/>
              </p:nvSpPr>
              <p:spPr>
                <a:xfrm>
                  <a:off x="8855243" y="3536711"/>
                  <a:ext cx="55335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FD</a:t>
                  </a:r>
                </a:p>
              </p:txBody>
            </p:sp>
            <p:cxnSp>
              <p:nvCxnSpPr>
                <p:cNvPr id="49" name="Straight Connector 48">
                  <a:extLst>
                    <a:ext uri="{FF2B5EF4-FFF2-40B4-BE49-F238E27FC236}">
                      <a16:creationId xmlns:a16="http://schemas.microsoft.com/office/drawing/2014/main" id="{58D31638-E2B0-BCC4-819D-0048074FE258}"/>
                    </a:ext>
                  </a:extLst>
                </p:cNvPr>
                <p:cNvCxnSpPr/>
                <p:nvPr/>
              </p:nvCxnSpPr>
              <p:spPr>
                <a:xfrm>
                  <a:off x="8385218" y="3505818"/>
                  <a:ext cx="870958" cy="0"/>
                </a:xfrm>
                <a:prstGeom prst="line">
                  <a:avLst/>
                </a:prstGeom>
                <a:ln w="28575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28" name="TextBox 20">
            <a:extLst>
              <a:ext uri="{FF2B5EF4-FFF2-40B4-BE49-F238E27FC236}">
                <a16:creationId xmlns:a16="http://schemas.microsoft.com/office/drawing/2014/main" id="{F91E3BBA-2556-D5A1-2C53-4C3F734D3A0C}"/>
              </a:ext>
            </a:extLst>
          </p:cNvPr>
          <p:cNvSpPr txBox="1"/>
          <p:nvPr/>
        </p:nvSpPr>
        <p:spPr>
          <a:xfrm>
            <a:off x="5929162" y="911109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29" name="テキスト ボックス 19">
            <a:extLst>
              <a:ext uri="{FF2B5EF4-FFF2-40B4-BE49-F238E27FC236}">
                <a16:creationId xmlns:a16="http://schemas.microsoft.com/office/drawing/2014/main" id="{798264A4-0DCF-DD7A-7ABB-7DD175C6429D}"/>
              </a:ext>
            </a:extLst>
          </p:cNvPr>
          <p:cNvSpPr txBox="1"/>
          <p:nvPr/>
        </p:nvSpPr>
        <p:spPr>
          <a:xfrm rot="16200000">
            <a:off x="5246213" y="2013163"/>
            <a:ext cx="2073858" cy="7205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ignal intensity</a:t>
            </a:r>
          </a:p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TGFβR2 /β-Actin)</a:t>
            </a:r>
          </a:p>
        </p:txBody>
      </p:sp>
      <p:graphicFrame>
        <p:nvGraphicFramePr>
          <p:cNvPr id="30" name="グラフ 74">
            <a:extLst>
              <a:ext uri="{FF2B5EF4-FFF2-40B4-BE49-F238E27FC236}">
                <a16:creationId xmlns:a16="http://schemas.microsoft.com/office/drawing/2014/main" id="{815165FC-07FE-0F89-7522-01B508C184D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0751232"/>
              </p:ext>
            </p:extLst>
          </p:nvPr>
        </p:nvGraphicFramePr>
        <p:xfrm>
          <a:off x="6563057" y="970935"/>
          <a:ext cx="5203601" cy="3319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1" name="テキスト ボックス 75">
            <a:extLst>
              <a:ext uri="{FF2B5EF4-FFF2-40B4-BE49-F238E27FC236}">
                <a16:creationId xmlns:a16="http://schemas.microsoft.com/office/drawing/2014/main" id="{F36CE457-A26A-98AB-8C56-B31A7217E229}"/>
              </a:ext>
            </a:extLst>
          </p:cNvPr>
          <p:cNvSpPr txBox="1"/>
          <p:nvPr/>
        </p:nvSpPr>
        <p:spPr>
          <a:xfrm>
            <a:off x="10275752" y="2003559"/>
            <a:ext cx="371317" cy="3351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32" name="テキスト ボックス 76">
            <a:extLst>
              <a:ext uri="{FF2B5EF4-FFF2-40B4-BE49-F238E27FC236}">
                <a16:creationId xmlns:a16="http://schemas.microsoft.com/office/drawing/2014/main" id="{2964C574-3DBD-6058-9C84-D3690C9DCB30}"/>
              </a:ext>
            </a:extLst>
          </p:cNvPr>
          <p:cNvSpPr txBox="1"/>
          <p:nvPr/>
        </p:nvSpPr>
        <p:spPr>
          <a:xfrm>
            <a:off x="10404261" y="1991787"/>
            <a:ext cx="371317" cy="3351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</a:p>
        </p:txBody>
      </p:sp>
      <p:sp>
        <p:nvSpPr>
          <p:cNvPr id="33" name="テキスト ボックス 77">
            <a:extLst>
              <a:ext uri="{FF2B5EF4-FFF2-40B4-BE49-F238E27FC236}">
                <a16:creationId xmlns:a16="http://schemas.microsoft.com/office/drawing/2014/main" id="{A2B427A1-59CF-EDFF-CEEC-96F609AB1DC0}"/>
              </a:ext>
            </a:extLst>
          </p:cNvPr>
          <p:cNvSpPr txBox="1"/>
          <p:nvPr/>
        </p:nvSpPr>
        <p:spPr>
          <a:xfrm>
            <a:off x="9575108" y="1817298"/>
            <a:ext cx="377938" cy="4468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4" name="テキスト ボックス 78">
            <a:extLst>
              <a:ext uri="{FF2B5EF4-FFF2-40B4-BE49-F238E27FC236}">
                <a16:creationId xmlns:a16="http://schemas.microsoft.com/office/drawing/2014/main" id="{49314CA3-5216-E0F3-6097-857B8C853266}"/>
              </a:ext>
            </a:extLst>
          </p:cNvPr>
          <p:cNvSpPr txBox="1"/>
          <p:nvPr/>
        </p:nvSpPr>
        <p:spPr>
          <a:xfrm>
            <a:off x="8043188" y="1587000"/>
            <a:ext cx="377938" cy="4468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08D22E9-0547-3438-C949-9E55EA05FB12}"/>
              </a:ext>
            </a:extLst>
          </p:cNvPr>
          <p:cNvSpPr txBox="1"/>
          <p:nvPr/>
        </p:nvSpPr>
        <p:spPr>
          <a:xfrm>
            <a:off x="4901650" y="259729"/>
            <a:ext cx="2521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</a:t>
            </a:r>
          </a:p>
        </p:txBody>
      </p:sp>
    </p:spTree>
    <p:extLst>
      <p:ext uri="{BB962C8B-B14F-4D97-AF65-F5344CB8AC3E}">
        <p14:creationId xmlns:p14="http://schemas.microsoft.com/office/powerpoint/2010/main" val="3216530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FA75677-C293-4710-F8F7-0B7C78C5F2B2}"/>
              </a:ext>
            </a:extLst>
          </p:cNvPr>
          <p:cNvSpPr txBox="1"/>
          <p:nvPr/>
        </p:nvSpPr>
        <p:spPr>
          <a:xfrm>
            <a:off x="361987" y="1365709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24">
            <a:extLst>
              <a:ext uri="{FF2B5EF4-FFF2-40B4-BE49-F238E27FC236}">
                <a16:creationId xmlns:a16="http://schemas.microsoft.com/office/drawing/2014/main" id="{DA911365-634C-6826-63DA-4CA08B35A268}"/>
              </a:ext>
            </a:extLst>
          </p:cNvPr>
          <p:cNvSpPr txBox="1"/>
          <p:nvPr/>
        </p:nvSpPr>
        <p:spPr>
          <a:xfrm>
            <a:off x="481156" y="3244984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DGFRβ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55">
            <a:extLst>
              <a:ext uri="{FF2B5EF4-FFF2-40B4-BE49-F238E27FC236}">
                <a16:creationId xmlns:a16="http://schemas.microsoft.com/office/drawing/2014/main" id="{87FC5C89-9D72-1EEA-BC37-0F851FBF73E8}"/>
              </a:ext>
            </a:extLst>
          </p:cNvPr>
          <p:cNvSpPr txBox="1"/>
          <p:nvPr/>
        </p:nvSpPr>
        <p:spPr>
          <a:xfrm>
            <a:off x="490649" y="3812310"/>
            <a:ext cx="8002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pic>
        <p:nvPicPr>
          <p:cNvPr id="6" name="図 30" descr="白黒の写真&#10;&#10;中程度の精度で自動的に生成された説明">
            <a:extLst>
              <a:ext uri="{FF2B5EF4-FFF2-40B4-BE49-F238E27FC236}">
                <a16:creationId xmlns:a16="http://schemas.microsoft.com/office/drawing/2014/main" id="{9F94C5A5-8B47-5126-7A1A-AF85BE5BCEC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55" t="46464" r="20528" b="48202"/>
          <a:stretch/>
        </p:blipFill>
        <p:spPr>
          <a:xfrm>
            <a:off x="1410335" y="3106521"/>
            <a:ext cx="4806047" cy="566506"/>
          </a:xfrm>
          <a:prstGeom prst="rect">
            <a:avLst/>
          </a:prstGeom>
        </p:spPr>
      </p:pic>
      <p:pic>
        <p:nvPicPr>
          <p:cNvPr id="7" name="図 31" descr="白い背景に黒い文字&#10;&#10;中程度の精度で自動的に生成された説明">
            <a:extLst>
              <a:ext uri="{FF2B5EF4-FFF2-40B4-BE49-F238E27FC236}">
                <a16:creationId xmlns:a16="http://schemas.microsoft.com/office/drawing/2014/main" id="{28E6A52C-AEA0-BC7D-5254-F5CAFB3614A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262" t="42120" r="8062" b="52604"/>
          <a:stretch/>
        </p:blipFill>
        <p:spPr>
          <a:xfrm>
            <a:off x="1405938" y="3728445"/>
            <a:ext cx="4810444" cy="51500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0EBD068-5935-431E-5722-839308BE282B}"/>
              </a:ext>
            </a:extLst>
          </p:cNvPr>
          <p:cNvSpPr txBox="1"/>
          <p:nvPr/>
        </p:nvSpPr>
        <p:spPr>
          <a:xfrm>
            <a:off x="2010502" y="2315613"/>
            <a:ext cx="6046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KY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60FE89C-0523-CFD1-C6FF-762153CE220B}"/>
              </a:ext>
            </a:extLst>
          </p:cNvPr>
          <p:cNvSpPr txBox="1"/>
          <p:nvPr/>
        </p:nvSpPr>
        <p:spPr>
          <a:xfrm>
            <a:off x="3462307" y="2323636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H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5E0AA0C-E52B-0366-FF5B-795BEB1E3010}"/>
              </a:ext>
            </a:extLst>
          </p:cNvPr>
          <p:cNvSpPr txBox="1"/>
          <p:nvPr/>
        </p:nvSpPr>
        <p:spPr>
          <a:xfrm>
            <a:off x="4777763" y="2323636"/>
            <a:ext cx="864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HR-SP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6B20B729-EC12-C857-F296-553AD7FDC83C}"/>
              </a:ext>
            </a:extLst>
          </p:cNvPr>
          <p:cNvGrpSpPr/>
          <p:nvPr/>
        </p:nvGrpSpPr>
        <p:grpSpPr>
          <a:xfrm>
            <a:off x="1793936" y="2669725"/>
            <a:ext cx="1122850" cy="338670"/>
            <a:chOff x="8285750" y="3505818"/>
            <a:chExt cx="1122850" cy="338670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E669348-6881-1105-F815-C16AC637F060}"/>
                </a:ext>
              </a:extLst>
            </p:cNvPr>
            <p:cNvSpPr txBox="1"/>
            <p:nvPr/>
          </p:nvSpPr>
          <p:spPr>
            <a:xfrm>
              <a:off x="8285750" y="3528689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988CA22-D318-CD06-3EA9-431E05D4F28A}"/>
                </a:ext>
              </a:extLst>
            </p:cNvPr>
            <p:cNvSpPr txBox="1"/>
            <p:nvPr/>
          </p:nvSpPr>
          <p:spPr>
            <a:xfrm>
              <a:off x="8855243" y="3536711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FD</a:t>
              </a: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883E0273-1BE1-D2C7-1C81-8919095C6AB7}"/>
                </a:ext>
              </a:extLst>
            </p:cNvPr>
            <p:cNvCxnSpPr/>
            <p:nvPr/>
          </p:nvCxnSpPr>
          <p:spPr>
            <a:xfrm>
              <a:off x="8385218" y="3505818"/>
              <a:ext cx="870958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07CB42F2-E91B-6164-6F7C-C1D52C95DEDF}"/>
              </a:ext>
            </a:extLst>
          </p:cNvPr>
          <p:cNvGrpSpPr/>
          <p:nvPr/>
        </p:nvGrpSpPr>
        <p:grpSpPr>
          <a:xfrm>
            <a:off x="3229703" y="2677747"/>
            <a:ext cx="1122850" cy="338670"/>
            <a:chOff x="8285750" y="3505818"/>
            <a:chExt cx="1122850" cy="338670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A3C4C6D-8D53-00EC-0F73-F7AC3DFC7661}"/>
                </a:ext>
              </a:extLst>
            </p:cNvPr>
            <p:cNvSpPr txBox="1"/>
            <p:nvPr/>
          </p:nvSpPr>
          <p:spPr>
            <a:xfrm>
              <a:off x="8285750" y="3528689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214E206-5AF9-8422-24D7-9672B4EB9C64}"/>
                </a:ext>
              </a:extLst>
            </p:cNvPr>
            <p:cNvSpPr txBox="1"/>
            <p:nvPr/>
          </p:nvSpPr>
          <p:spPr>
            <a:xfrm>
              <a:off x="8855243" y="3536711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FD</a:t>
              </a: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9D3135D9-AE5B-0206-38A5-097FF9DF32F7}"/>
                </a:ext>
              </a:extLst>
            </p:cNvPr>
            <p:cNvCxnSpPr/>
            <p:nvPr/>
          </p:nvCxnSpPr>
          <p:spPr>
            <a:xfrm>
              <a:off x="8385218" y="3505818"/>
              <a:ext cx="870958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8543FE1E-77C7-35C7-0B5B-03C283E90395}"/>
              </a:ext>
            </a:extLst>
          </p:cNvPr>
          <p:cNvGrpSpPr/>
          <p:nvPr/>
        </p:nvGrpSpPr>
        <p:grpSpPr>
          <a:xfrm>
            <a:off x="4673488" y="2677747"/>
            <a:ext cx="1122850" cy="338670"/>
            <a:chOff x="8285750" y="3505818"/>
            <a:chExt cx="1122850" cy="338670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D88E55E-D386-0C80-AA0C-3CC724CA33D7}"/>
                </a:ext>
              </a:extLst>
            </p:cNvPr>
            <p:cNvSpPr txBox="1"/>
            <p:nvPr/>
          </p:nvSpPr>
          <p:spPr>
            <a:xfrm>
              <a:off x="8285750" y="3528689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41C356C-0D0D-DE75-D420-12F0A23E364E}"/>
                </a:ext>
              </a:extLst>
            </p:cNvPr>
            <p:cNvSpPr txBox="1"/>
            <p:nvPr/>
          </p:nvSpPr>
          <p:spPr>
            <a:xfrm>
              <a:off x="8855243" y="3536711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FD</a:t>
              </a: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762791CF-E2E4-1A92-C3B1-7CC32DD1071D}"/>
                </a:ext>
              </a:extLst>
            </p:cNvPr>
            <p:cNvCxnSpPr/>
            <p:nvPr/>
          </p:nvCxnSpPr>
          <p:spPr>
            <a:xfrm>
              <a:off x="8385218" y="3505818"/>
              <a:ext cx="870958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3" name="テキスト ボックス 1">
            <a:extLst>
              <a:ext uri="{FF2B5EF4-FFF2-40B4-BE49-F238E27FC236}">
                <a16:creationId xmlns:a16="http://schemas.microsoft.com/office/drawing/2014/main" id="{48C3DF55-3C59-31F4-8125-6D94B2EF122D}"/>
              </a:ext>
            </a:extLst>
          </p:cNvPr>
          <p:cNvSpPr txBox="1"/>
          <p:nvPr/>
        </p:nvSpPr>
        <p:spPr>
          <a:xfrm>
            <a:off x="6288679" y="1349942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19">
            <a:extLst>
              <a:ext uri="{FF2B5EF4-FFF2-40B4-BE49-F238E27FC236}">
                <a16:creationId xmlns:a16="http://schemas.microsoft.com/office/drawing/2014/main" id="{B3627CA2-1A32-3FB4-0902-12C3E7B8752D}"/>
              </a:ext>
            </a:extLst>
          </p:cNvPr>
          <p:cNvSpPr txBox="1"/>
          <p:nvPr/>
        </p:nvSpPr>
        <p:spPr>
          <a:xfrm rot="16200000">
            <a:off x="5868039" y="2517054"/>
            <a:ext cx="175560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ignal intensity</a:t>
            </a:r>
          </a:p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PDGFβR /β-Actin)</a:t>
            </a:r>
          </a:p>
        </p:txBody>
      </p:sp>
      <p:graphicFrame>
        <p:nvGraphicFramePr>
          <p:cNvPr id="25" name="グラフ 69">
            <a:extLst>
              <a:ext uri="{FF2B5EF4-FFF2-40B4-BE49-F238E27FC236}">
                <a16:creationId xmlns:a16="http://schemas.microsoft.com/office/drawing/2014/main" id="{E9BBEC59-E058-8F7F-9285-14C914EBF5F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2343741"/>
              </p:ext>
            </p:extLst>
          </p:nvPr>
        </p:nvGraphicFramePr>
        <p:xfrm>
          <a:off x="7026889" y="1454517"/>
          <a:ext cx="5066299" cy="3319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6" name="テキスト ボックス 71">
            <a:extLst>
              <a:ext uri="{FF2B5EF4-FFF2-40B4-BE49-F238E27FC236}">
                <a16:creationId xmlns:a16="http://schemas.microsoft.com/office/drawing/2014/main" id="{38E3442A-D4E5-38FD-19EE-DB93343FC17C}"/>
              </a:ext>
            </a:extLst>
          </p:cNvPr>
          <p:cNvSpPr txBox="1"/>
          <p:nvPr/>
        </p:nvSpPr>
        <p:spPr>
          <a:xfrm>
            <a:off x="8487931" y="1845852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D876C96-5933-AE70-C723-1D59D92C602B}"/>
              </a:ext>
            </a:extLst>
          </p:cNvPr>
          <p:cNvSpPr txBox="1"/>
          <p:nvPr/>
        </p:nvSpPr>
        <p:spPr>
          <a:xfrm>
            <a:off x="4901650" y="259729"/>
            <a:ext cx="2521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2066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1</TotalTime>
  <Words>119</Words>
  <Application>Microsoft Office PowerPoint</Application>
  <PresentationFormat>Widescreen</PresentationFormat>
  <Paragraphs>66</Paragraphs>
  <Slides>5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ikh Abdullah</dc:creator>
  <cp:lastModifiedBy>MDPI</cp:lastModifiedBy>
  <cp:revision>3</cp:revision>
  <dcterms:created xsi:type="dcterms:W3CDTF">2025-06-16T06:25:33Z</dcterms:created>
  <dcterms:modified xsi:type="dcterms:W3CDTF">2025-08-20T09:05:45Z</dcterms:modified>
</cp:coreProperties>
</file>